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67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7464046-3993-4704-9E46-2C0231A970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F0FDC7CD-0951-4C7C-913E-11BC099A3C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B83F021-01DB-47B8-BC6E-960F34137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0405459-B523-46B4-A1BD-55A10827B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654D5B7-07A8-4D8A-ACAF-7D01DE140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420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EF0791F-E49C-45D3-96A6-468639C4F2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9761BADF-7971-4B8A-8F3D-528A0DDE8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C899101-396C-4A13-B84F-94C8C6450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4666E1E-4090-48FF-80EB-73B1CC644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175DF04-4C58-48AB-AB14-03931D823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4211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49432A60-1DD6-48F1-AF67-24E20041EF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BF00DBBD-02E3-4689-8844-C8F23B4984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2A264E1-C9F0-4E4C-99A5-4EB7E204A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CEFBA9A-9A75-4432-BEEA-4810FEC00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694750E-1ACB-4E16-86CC-1A2198006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08635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7DAB4F0-C2AF-4B3E-9A0F-4E2804BD91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EA61D21-FF79-4314-A580-B0C97ACCD3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6515CB6-D975-440E-8F33-2A6421C17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EFD3783-CD89-49FD-9539-A8B17FA77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55D3DB7-E18C-4248-9586-460CA5738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0052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DB906B7-CED7-43ED-BE67-FDD4E9E6C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8818E8BB-CC2E-4B62-B81C-AC6D25D083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D833A70-3A2A-4403-9A5F-E17EB597E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963D334-C119-484B-A8C6-4F6EE008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4546359-A929-40F9-A3D1-981B099FD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9926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D5A39BA-31EB-4692-9838-9ABBE1910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B239ACE-5602-48C8-98BB-899E753570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1D6E5FA-F09C-434F-A982-CADF6F5E74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1E3FF7A7-562D-4249-AD88-2F266B7C2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9B7BC95-A64A-4666-BB7D-6DDE0768A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D1B5F393-5C94-4924-A79D-DD70E649C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37675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C3971CA-DD04-4B4B-95A2-E11BA82A3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89F37FF-E973-4CDD-8492-5F31561C0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9BF00AA6-5F74-4E1A-8006-CF728C2443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EAA35FB1-D935-4F76-BBD4-23B441FCCC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703AEA1D-F4C7-4260-9EDA-AD5068FA86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2A4FBBF3-6B52-4FF0-9E5C-84E7E1A4A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890047CA-E1CA-42E4-AA74-CEBD2C8FC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21F448B2-BF5A-48D4-A01D-99C7F79D9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3667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5498CCD-443A-494A-A1F7-A0DE21D06B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6EED5C83-4F28-49A4-9FCC-88866AE9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1FAD52D8-7BEF-48A9-94A7-72339F7B6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6CB49148-6334-47AE-BDCA-D228574B2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47322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574364EF-05B7-4E3D-8D3B-F824006AC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7CA6B951-EA14-4ACB-B4AE-F383E56E9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80318976-27AE-4156-88BE-BBD6754A2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14610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49BEAF4-3793-4D19-B8B7-4A3095BBD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87C548B-1B6A-4747-BFFB-3A98C53CF6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F5A690BF-D0DC-400D-890E-9B31078E06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CE913F3-E91F-4D67-ABAB-B665417B2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B8988CF-BA5C-45A7-9343-DFB508F75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B167F81E-3871-4424-ADED-7175BE677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797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979A972-A5A6-4597-A8BF-A1A57E854A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2D874E12-5B67-49F0-B226-54404781CA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A06ACC89-7297-41DF-81A1-DE2F9456BB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2A64222-8009-4934-954B-DCFD7103B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CC3DE38-1320-46B3-8FF1-13026A855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63B98BAB-A954-4264-84AD-10233A05B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5386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E2177E6E-9908-4C1E-B0A2-972259B0D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16CFF12-B9EC-4EF1-8EAB-FE106DBEEB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35134C5-E498-459F-825C-4697D6B1D4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A04C2-B1FA-426F-8D43-F57618D755A6}" type="datetimeFigureOut">
              <a:rPr lang="zh-TW" altLang="en-US" smtClean="0"/>
              <a:t>2025/12/1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8DB86BD-506F-4661-ABF3-0360D0AF04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2456778-51D2-44E3-AC66-58E9FD1E5A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8EC0D6-DCD0-4DE0-B925-7903296BFE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37099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字方塊 25">
            <a:extLst>
              <a:ext uri="{FF2B5EF4-FFF2-40B4-BE49-F238E27FC236}">
                <a16:creationId xmlns:a16="http://schemas.microsoft.com/office/drawing/2014/main" id="{46902BFB-2E59-429B-B41A-634C1A142602}"/>
              </a:ext>
            </a:extLst>
          </p:cNvPr>
          <p:cNvSpPr txBox="1"/>
          <p:nvPr/>
        </p:nvSpPr>
        <p:spPr>
          <a:xfrm>
            <a:off x="355600" y="477520"/>
            <a:ext cx="115011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ure. Sequencing chromatograms showing the nucleotide changes underlying the N868D (A) and R52H (B) amino acid substitutions. For N868D, NN, ND, and DD represent the wild-type, heterozygous, and homozygous genotypes, respectively; similarly, RR, RH, and HH represent the corresponding genotypes for R52H. Nucleotide sequences are shown before the colon, and the corresponding amino acid states are shown after the colon.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群組 32">
            <a:extLst>
              <a:ext uri="{FF2B5EF4-FFF2-40B4-BE49-F238E27FC236}">
                <a16:creationId xmlns:a16="http://schemas.microsoft.com/office/drawing/2014/main" id="{F6029DDB-A597-47EB-8F14-341924080050}"/>
              </a:ext>
            </a:extLst>
          </p:cNvPr>
          <p:cNvGrpSpPr/>
          <p:nvPr/>
        </p:nvGrpSpPr>
        <p:grpSpPr>
          <a:xfrm>
            <a:off x="137477" y="2066259"/>
            <a:ext cx="11917046" cy="4015643"/>
            <a:chOff x="36888" y="1849442"/>
            <a:chExt cx="11917046" cy="4015643"/>
          </a:xfrm>
        </p:grpSpPr>
        <p:grpSp>
          <p:nvGrpSpPr>
            <p:cNvPr id="27" name="群組 26">
              <a:extLst>
                <a:ext uri="{FF2B5EF4-FFF2-40B4-BE49-F238E27FC236}">
                  <a16:creationId xmlns:a16="http://schemas.microsoft.com/office/drawing/2014/main" id="{56E380F9-62F2-4D6B-A3DA-F3C890BBF320}"/>
                </a:ext>
              </a:extLst>
            </p:cNvPr>
            <p:cNvGrpSpPr/>
            <p:nvPr/>
          </p:nvGrpSpPr>
          <p:grpSpPr>
            <a:xfrm>
              <a:off x="6106160" y="2320973"/>
              <a:ext cx="5847774" cy="3544111"/>
              <a:chOff x="140255" y="1981200"/>
              <a:chExt cx="5847774" cy="3544111"/>
            </a:xfrm>
          </p:grpSpPr>
          <p:pic>
            <p:nvPicPr>
              <p:cNvPr id="5" name="圖片 4">
                <a:extLst>
                  <a:ext uri="{FF2B5EF4-FFF2-40B4-BE49-F238E27FC236}">
                    <a16:creationId xmlns:a16="http://schemas.microsoft.com/office/drawing/2014/main" id="{89D4951B-928C-44D0-AD01-D3D412F021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7912" t="26898" r="46727" b="36357"/>
              <a:stretch/>
            </p:blipFill>
            <p:spPr>
              <a:xfrm>
                <a:off x="140255" y="2107245"/>
                <a:ext cx="5847774" cy="3418066"/>
              </a:xfrm>
              <a:prstGeom prst="rect">
                <a:avLst/>
              </a:prstGeom>
            </p:spPr>
          </p:pic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DEDF026E-94F7-4DD4-AE55-E3E47988AA2D}"/>
                  </a:ext>
                </a:extLst>
              </p:cNvPr>
              <p:cNvSpPr/>
              <p:nvPr/>
            </p:nvSpPr>
            <p:spPr>
              <a:xfrm>
                <a:off x="2763520" y="1981200"/>
                <a:ext cx="782320" cy="3544111"/>
              </a:xfrm>
              <a:prstGeom prst="rect">
                <a:avLst/>
              </a:prstGeom>
              <a:solidFill>
                <a:srgbClr val="7030A0">
                  <a:alpha val="1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字方塊 12">
                <a:extLst>
                  <a:ext uri="{FF2B5EF4-FFF2-40B4-BE49-F238E27FC236}">
                    <a16:creationId xmlns:a16="http://schemas.microsoft.com/office/drawing/2014/main" id="{26E345C0-2EF4-430C-85AA-4F5C58A68C15}"/>
                  </a:ext>
                </a:extLst>
              </p:cNvPr>
              <p:cNvSpPr txBox="1"/>
              <p:nvPr/>
            </p:nvSpPr>
            <p:spPr>
              <a:xfrm>
                <a:off x="2610300" y="2082801"/>
                <a:ext cx="10887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C: RR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字方塊 13">
                <a:extLst>
                  <a:ext uri="{FF2B5EF4-FFF2-40B4-BE49-F238E27FC236}">
                    <a16:creationId xmlns:a16="http://schemas.microsoft.com/office/drawing/2014/main" id="{2BE1D540-8BAB-4ABA-9F3A-EC5CEBEE6A64}"/>
                  </a:ext>
                </a:extLst>
              </p:cNvPr>
              <p:cNvSpPr txBox="1"/>
              <p:nvPr/>
            </p:nvSpPr>
            <p:spPr>
              <a:xfrm>
                <a:off x="2597476" y="4312644"/>
                <a:ext cx="11144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C: HH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字方塊 14">
                <a:extLst>
                  <a:ext uri="{FF2B5EF4-FFF2-40B4-BE49-F238E27FC236}">
                    <a16:creationId xmlns:a16="http://schemas.microsoft.com/office/drawing/2014/main" id="{F935D0CF-7420-4B7E-8312-427A93E28324}"/>
                  </a:ext>
                </a:extLst>
              </p:cNvPr>
              <p:cNvSpPr txBox="1"/>
              <p:nvPr/>
            </p:nvSpPr>
            <p:spPr>
              <a:xfrm>
                <a:off x="2411528" y="3152002"/>
                <a:ext cx="14863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(G/A)C: RH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8" name="群組 27">
              <a:extLst>
                <a:ext uri="{FF2B5EF4-FFF2-40B4-BE49-F238E27FC236}">
                  <a16:creationId xmlns:a16="http://schemas.microsoft.com/office/drawing/2014/main" id="{EFD2AD4A-CDA1-4F2B-95E0-4F638E100CFE}"/>
                </a:ext>
              </a:extLst>
            </p:cNvPr>
            <p:cNvGrpSpPr/>
            <p:nvPr/>
          </p:nvGrpSpPr>
          <p:grpSpPr>
            <a:xfrm>
              <a:off x="179128" y="2320974"/>
              <a:ext cx="5847774" cy="3544111"/>
              <a:chOff x="6169103" y="1971040"/>
              <a:chExt cx="5847774" cy="3544111"/>
            </a:xfrm>
          </p:grpSpPr>
          <p:pic>
            <p:nvPicPr>
              <p:cNvPr id="21" name="圖片 20">
                <a:extLst>
                  <a:ext uri="{FF2B5EF4-FFF2-40B4-BE49-F238E27FC236}">
                    <a16:creationId xmlns:a16="http://schemas.microsoft.com/office/drawing/2014/main" id="{F7549F18-F0E1-4491-AFCF-AC59C3D1AB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1386" t="23092" r="41798" b="40268"/>
              <a:stretch/>
            </p:blipFill>
            <p:spPr>
              <a:xfrm>
                <a:off x="6169103" y="2107245"/>
                <a:ext cx="5847774" cy="3407906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D1B07036-B3C7-499E-8CD7-925DF1E6FFF3}"/>
                  </a:ext>
                </a:extLst>
              </p:cNvPr>
              <p:cNvSpPr/>
              <p:nvPr/>
            </p:nvSpPr>
            <p:spPr>
              <a:xfrm>
                <a:off x="9635356" y="1971040"/>
                <a:ext cx="782320" cy="3544111"/>
              </a:xfrm>
              <a:prstGeom prst="rect">
                <a:avLst/>
              </a:prstGeom>
              <a:solidFill>
                <a:srgbClr val="7030A0">
                  <a:alpha val="1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字方塊 22">
                <a:extLst>
                  <a:ext uri="{FF2B5EF4-FFF2-40B4-BE49-F238E27FC236}">
                    <a16:creationId xmlns:a16="http://schemas.microsoft.com/office/drawing/2014/main" id="{03879D5D-FE58-4AAE-88C0-ACE04902FEC1}"/>
                  </a:ext>
                </a:extLst>
              </p:cNvPr>
              <p:cNvSpPr txBox="1"/>
              <p:nvPr/>
            </p:nvSpPr>
            <p:spPr>
              <a:xfrm>
                <a:off x="9462900" y="2072640"/>
                <a:ext cx="11272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C: NN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字方塊 23">
                <a:extLst>
                  <a:ext uri="{FF2B5EF4-FFF2-40B4-BE49-F238E27FC236}">
                    <a16:creationId xmlns:a16="http://schemas.microsoft.com/office/drawing/2014/main" id="{E7AD5043-D6E9-450D-BBE2-A2519B05A828}"/>
                  </a:ext>
                </a:extLst>
              </p:cNvPr>
              <p:cNvSpPr txBox="1"/>
              <p:nvPr/>
            </p:nvSpPr>
            <p:spPr>
              <a:xfrm>
                <a:off x="9462900" y="4302483"/>
                <a:ext cx="11272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C: DD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字方塊 24">
                <a:extLst>
                  <a:ext uri="{FF2B5EF4-FFF2-40B4-BE49-F238E27FC236}">
                    <a16:creationId xmlns:a16="http://schemas.microsoft.com/office/drawing/2014/main" id="{A3A4A373-CE4F-48A7-A9FD-F41C818A626E}"/>
                  </a:ext>
                </a:extLst>
              </p:cNvPr>
              <p:cNvSpPr txBox="1"/>
              <p:nvPr/>
            </p:nvSpPr>
            <p:spPr>
              <a:xfrm>
                <a:off x="9275525" y="3141841"/>
                <a:ext cx="15119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/G)AC: ND</a:t>
                </a:r>
                <a:endParaRPr lang="zh-TW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E111F312-16F6-4BA7-85B7-1B2F81C05B9A}"/>
                </a:ext>
              </a:extLst>
            </p:cNvPr>
            <p:cNvSpPr txBox="1"/>
            <p:nvPr/>
          </p:nvSpPr>
          <p:spPr>
            <a:xfrm>
              <a:off x="36888" y="1853324"/>
              <a:ext cx="50328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字方塊 31">
              <a:extLst>
                <a:ext uri="{FF2B5EF4-FFF2-40B4-BE49-F238E27FC236}">
                  <a16:creationId xmlns:a16="http://schemas.microsoft.com/office/drawing/2014/main" id="{C8E8DE66-6377-43E9-92FE-B90E72DBDEB0}"/>
                </a:ext>
              </a:extLst>
            </p:cNvPr>
            <p:cNvSpPr txBox="1"/>
            <p:nvPr/>
          </p:nvSpPr>
          <p:spPr>
            <a:xfrm>
              <a:off x="5923280" y="1849442"/>
              <a:ext cx="61331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9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4</TotalTime>
  <Words>115</Words>
  <Application>Microsoft Office PowerPoint</Application>
  <PresentationFormat>寬螢幕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鍾瀚璿</dc:creator>
  <cp:lastModifiedBy>鍾瀚璿</cp:lastModifiedBy>
  <cp:revision>1</cp:revision>
  <dcterms:created xsi:type="dcterms:W3CDTF">2025-12-19T05:53:22Z</dcterms:created>
  <dcterms:modified xsi:type="dcterms:W3CDTF">2025-12-23T06:07:25Z</dcterms:modified>
</cp:coreProperties>
</file>